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991" autoAdjust="0"/>
    <p:restoredTop sz="94660"/>
  </p:normalViewPr>
  <p:slideViewPr>
    <p:cSldViewPr snapToGrid="0">
      <p:cViewPr varScale="1">
        <p:scale>
          <a:sx n="132" d="100"/>
          <a:sy n="132" d="100"/>
        </p:scale>
        <p:origin x="156" y="8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gtvault-my.sharepoint.com/personal/schockalingam6_gatech_edu1/Documents/I3-Networks/All-Tabl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gtvault-my.sharepoint.com/personal/schockalingam6_gatech_edu1/Documents/I3-Networks/All-Tabl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31745625262305"/>
          <c:y val="7.4222613137212484E-2"/>
          <c:w val="0.73919214249670384"/>
          <c:h val="0.7656291574012829"/>
        </c:manualLayout>
      </c:layout>
      <c:scatterChart>
        <c:scatterStyle val="lineMarker"/>
        <c:varyColors val="0"/>
        <c:ser>
          <c:idx val="0"/>
          <c:order val="0"/>
          <c:tx>
            <c:strRef>
              <c:f>'Table S6'!$G$11</c:f>
              <c:strCache>
                <c:ptCount val="1"/>
                <c:pt idx="0">
                  <c:v>ComBat</c:v>
                </c:pt>
              </c:strCache>
            </c:strRef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xVal>
            <c:numRef>
              <c:f>'Table S6'!$C$12:$C$18</c:f>
              <c:numCache>
                <c:formatCode>#,##0</c:formatCode>
                <c:ptCount val="7"/>
                <c:pt idx="0">
                  <c:v>7245</c:v>
                </c:pt>
                <c:pt idx="1">
                  <c:v>19167</c:v>
                </c:pt>
                <c:pt idx="2">
                  <c:v>42132</c:v>
                </c:pt>
                <c:pt idx="3">
                  <c:v>86692</c:v>
                </c:pt>
                <c:pt idx="4">
                  <c:v>166932</c:v>
                </c:pt>
                <c:pt idx="5">
                  <c:v>187564</c:v>
                </c:pt>
                <c:pt idx="6">
                  <c:v>794170</c:v>
                </c:pt>
              </c:numCache>
            </c:numRef>
          </c:xVal>
          <c:yVal>
            <c:numRef>
              <c:f>'Table S6'!$G$12:$G$18</c:f>
              <c:numCache>
                <c:formatCode>0.00</c:formatCode>
                <c:ptCount val="7"/>
                <c:pt idx="0">
                  <c:v>6.3648681640625</c:v>
                </c:pt>
                <c:pt idx="1">
                  <c:v>18.531661987304599</c:v>
                </c:pt>
                <c:pt idx="2">
                  <c:v>42.757049560546797</c:v>
                </c:pt>
                <c:pt idx="3">
                  <c:v>88.278999328613196</c:v>
                </c:pt>
                <c:pt idx="4">
                  <c:v>167.58841323852499</c:v>
                </c:pt>
                <c:pt idx="5">
                  <c:v>190.69165420532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5CE-4F13-8E53-538F03940E06}"/>
            </c:ext>
          </c:extLst>
        </c:ser>
        <c:ser>
          <c:idx val="1"/>
          <c:order val="1"/>
          <c:tx>
            <c:strRef>
              <c:f>'Table S6'!$H$11</c:f>
              <c:strCache>
                <c:ptCount val="1"/>
                <c:pt idx="0">
                  <c:v>PySCEMENT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S6'!$C$12:$C$18</c:f>
              <c:numCache>
                <c:formatCode>#,##0</c:formatCode>
                <c:ptCount val="7"/>
                <c:pt idx="0">
                  <c:v>7245</c:v>
                </c:pt>
                <c:pt idx="1">
                  <c:v>19167</c:v>
                </c:pt>
                <c:pt idx="2">
                  <c:v>42132</c:v>
                </c:pt>
                <c:pt idx="3">
                  <c:v>86692</c:v>
                </c:pt>
                <c:pt idx="4">
                  <c:v>166932</c:v>
                </c:pt>
                <c:pt idx="5">
                  <c:v>187564</c:v>
                </c:pt>
                <c:pt idx="6">
                  <c:v>794170</c:v>
                </c:pt>
              </c:numCache>
            </c:numRef>
          </c:xVal>
          <c:yVal>
            <c:numRef>
              <c:f>'Table S6'!$H$12:$H$18</c:f>
              <c:numCache>
                <c:formatCode>0.00</c:formatCode>
                <c:ptCount val="7"/>
                <c:pt idx="0">
                  <c:v>1.5435981750488281</c:v>
                </c:pt>
                <c:pt idx="1">
                  <c:v>4.2159461975097656</c:v>
                </c:pt>
                <c:pt idx="2">
                  <c:v>9.3589515686035156</c:v>
                </c:pt>
                <c:pt idx="3">
                  <c:v>19.690193176269531</c:v>
                </c:pt>
                <c:pt idx="4">
                  <c:v>36.198104858398438</c:v>
                </c:pt>
                <c:pt idx="5">
                  <c:v>41.147571563720703</c:v>
                </c:pt>
                <c:pt idx="6">
                  <c:v>215.735740661621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5CE-4F13-8E53-538F03940E06}"/>
            </c:ext>
          </c:extLst>
        </c:ser>
        <c:ser>
          <c:idx val="2"/>
          <c:order val="2"/>
          <c:tx>
            <c:strRef>
              <c:f>'Table S6'!$I$11</c:f>
              <c:strCache>
                <c:ptCount val="1"/>
                <c:pt idx="0">
                  <c:v>SCEMENT-CPP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able S6'!$C$12:$C$18</c:f>
              <c:numCache>
                <c:formatCode>#,##0</c:formatCode>
                <c:ptCount val="7"/>
                <c:pt idx="0">
                  <c:v>7245</c:v>
                </c:pt>
                <c:pt idx="1">
                  <c:v>19167</c:v>
                </c:pt>
                <c:pt idx="2">
                  <c:v>42132</c:v>
                </c:pt>
                <c:pt idx="3">
                  <c:v>86692</c:v>
                </c:pt>
                <c:pt idx="4">
                  <c:v>166932</c:v>
                </c:pt>
                <c:pt idx="5">
                  <c:v>187564</c:v>
                </c:pt>
                <c:pt idx="6">
                  <c:v>794170</c:v>
                </c:pt>
              </c:numCache>
            </c:numRef>
          </c:xVal>
          <c:yVal>
            <c:numRef>
              <c:f>'Table S6'!$I$12:$I$18</c:f>
              <c:numCache>
                <c:formatCode>0.00</c:formatCode>
                <c:ptCount val="7"/>
                <c:pt idx="0">
                  <c:v>0.74630355834960904</c:v>
                </c:pt>
                <c:pt idx="1">
                  <c:v>2.28079986572265</c:v>
                </c:pt>
                <c:pt idx="2">
                  <c:v>5.1479148864745996</c:v>
                </c:pt>
                <c:pt idx="3">
                  <c:v>10.9609222412109</c:v>
                </c:pt>
                <c:pt idx="4">
                  <c:v>19.577571868896399</c:v>
                </c:pt>
                <c:pt idx="5">
                  <c:v>22.247543334960898</c:v>
                </c:pt>
                <c:pt idx="6">
                  <c:v>114.12576675415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5CE-4F13-8E53-538F03940E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8312032"/>
        <c:axId val="1528314112"/>
      </c:scatterChart>
      <c:valAx>
        <c:axId val="1528312032"/>
        <c:scaling>
          <c:orientation val="minMax"/>
          <c:max val="8000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o. of Cells</a:t>
                </a:r>
              </a:p>
            </c:rich>
          </c:tx>
          <c:layout>
            <c:manualLayout>
              <c:xMode val="edge"/>
              <c:yMode val="edge"/>
              <c:x val="0.44385296306726485"/>
              <c:y val="0.918059190174294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\K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4112"/>
        <c:crossesAt val="0"/>
        <c:crossBetween val="midCat"/>
        <c:majorUnit val="100000"/>
        <c:minorUnit val="50000"/>
        <c:dispUnits>
          <c:builtInUnit val="thousands"/>
        </c:dispUnits>
      </c:valAx>
      <c:valAx>
        <c:axId val="1528314112"/>
        <c:scaling>
          <c:orientation val="minMax"/>
          <c:max val="2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Memory (GB)</a:t>
                </a:r>
              </a:p>
            </c:rich>
          </c:tx>
          <c:layout>
            <c:manualLayout>
              <c:xMode val="edge"/>
              <c:yMode val="edge"/>
              <c:x val="2.7841335829747148E-2"/>
              <c:y val="0.342855440779371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2032"/>
        <c:crossesAt val="0"/>
        <c:crossBetween val="midCat"/>
        <c:min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latin typeface="Concourse T6" pitchFamily="2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31135320339095"/>
          <c:y val="7.4222613137212484E-2"/>
          <c:w val="0.74019824554593594"/>
          <c:h val="0.76561206029721163"/>
        </c:manualLayout>
      </c:layout>
      <c:scatterChart>
        <c:scatterStyle val="lineMarker"/>
        <c:varyColors val="0"/>
        <c:ser>
          <c:idx val="0"/>
          <c:order val="0"/>
          <c:tx>
            <c:strRef>
              <c:f>'Table S6'!$G$2</c:f>
              <c:strCache>
                <c:ptCount val="1"/>
                <c:pt idx="0">
                  <c:v>ComBat</c:v>
                </c:pt>
              </c:strCache>
            </c:strRef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xVal>
            <c:numRef>
              <c:f>'Table S6'!$C$3:$C$9</c:f>
              <c:numCache>
                <c:formatCode>#,##0</c:formatCode>
                <c:ptCount val="7"/>
                <c:pt idx="0">
                  <c:v>7245</c:v>
                </c:pt>
                <c:pt idx="1">
                  <c:v>19167</c:v>
                </c:pt>
                <c:pt idx="2">
                  <c:v>42132</c:v>
                </c:pt>
                <c:pt idx="3">
                  <c:v>86692</c:v>
                </c:pt>
                <c:pt idx="4">
                  <c:v>166932</c:v>
                </c:pt>
                <c:pt idx="5">
                  <c:v>187564</c:v>
                </c:pt>
                <c:pt idx="6">
                  <c:v>794170</c:v>
                </c:pt>
              </c:numCache>
            </c:numRef>
          </c:xVal>
          <c:yVal>
            <c:numRef>
              <c:f>'Table S6'!$G$3:$G$9</c:f>
              <c:numCache>
                <c:formatCode>0.00</c:formatCode>
                <c:ptCount val="7"/>
                <c:pt idx="0">
                  <c:v>25.904199999999999</c:v>
                </c:pt>
                <c:pt idx="1">
                  <c:v>80.663200000000003</c:v>
                </c:pt>
                <c:pt idx="2">
                  <c:v>191.1542</c:v>
                </c:pt>
                <c:pt idx="3">
                  <c:v>431.4819</c:v>
                </c:pt>
                <c:pt idx="4">
                  <c:v>859.53229999999996</c:v>
                </c:pt>
                <c:pt idx="5">
                  <c:v>1070.602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2CF-4EE6-8B07-D322ABA28112}"/>
            </c:ext>
          </c:extLst>
        </c:ser>
        <c:ser>
          <c:idx val="1"/>
          <c:order val="1"/>
          <c:tx>
            <c:strRef>
              <c:f>'Table S6'!$H$2</c:f>
              <c:strCache>
                <c:ptCount val="1"/>
                <c:pt idx="0">
                  <c:v>PySCEMENT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S6'!$C$3:$C$9</c:f>
              <c:numCache>
                <c:formatCode>#,##0</c:formatCode>
                <c:ptCount val="7"/>
                <c:pt idx="0">
                  <c:v>7245</c:v>
                </c:pt>
                <c:pt idx="1">
                  <c:v>19167</c:v>
                </c:pt>
                <c:pt idx="2">
                  <c:v>42132</c:v>
                </c:pt>
                <c:pt idx="3">
                  <c:v>86692</c:v>
                </c:pt>
                <c:pt idx="4">
                  <c:v>166932</c:v>
                </c:pt>
                <c:pt idx="5">
                  <c:v>187564</c:v>
                </c:pt>
                <c:pt idx="6">
                  <c:v>794170</c:v>
                </c:pt>
              </c:numCache>
            </c:numRef>
          </c:xVal>
          <c:yVal>
            <c:numRef>
              <c:f>'Table S6'!$H$3:$H$9</c:f>
              <c:numCache>
                <c:formatCode>0.00</c:formatCode>
                <c:ptCount val="7"/>
                <c:pt idx="0">
                  <c:v>13.6</c:v>
                </c:pt>
                <c:pt idx="1">
                  <c:v>37.200000000000003</c:v>
                </c:pt>
                <c:pt idx="2">
                  <c:v>76.900000000000006</c:v>
                </c:pt>
                <c:pt idx="3">
                  <c:v>159.1</c:v>
                </c:pt>
                <c:pt idx="4">
                  <c:v>270.89999999999998</c:v>
                </c:pt>
                <c:pt idx="5">
                  <c:v>318.8</c:v>
                </c:pt>
                <c:pt idx="6">
                  <c:v>211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2CF-4EE6-8B07-D322ABA28112}"/>
            </c:ext>
          </c:extLst>
        </c:ser>
        <c:ser>
          <c:idx val="2"/>
          <c:order val="2"/>
          <c:tx>
            <c:strRef>
              <c:f>'Table S6'!$I$2</c:f>
              <c:strCache>
                <c:ptCount val="1"/>
                <c:pt idx="0">
                  <c:v>SCEMENT-CPP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able S6'!$C$3:$C$9</c:f>
              <c:numCache>
                <c:formatCode>#,##0</c:formatCode>
                <c:ptCount val="7"/>
                <c:pt idx="0">
                  <c:v>7245</c:v>
                </c:pt>
                <c:pt idx="1">
                  <c:v>19167</c:v>
                </c:pt>
                <c:pt idx="2">
                  <c:v>42132</c:v>
                </c:pt>
                <c:pt idx="3">
                  <c:v>86692</c:v>
                </c:pt>
                <c:pt idx="4">
                  <c:v>166932</c:v>
                </c:pt>
                <c:pt idx="5">
                  <c:v>187564</c:v>
                </c:pt>
                <c:pt idx="6">
                  <c:v>794170</c:v>
                </c:pt>
              </c:numCache>
            </c:numRef>
          </c:xVal>
          <c:yVal>
            <c:numRef>
              <c:f>'Table S6'!$I$3:$I$9</c:f>
              <c:numCache>
                <c:formatCode>0.00</c:formatCode>
                <c:ptCount val="7"/>
                <c:pt idx="0">
                  <c:v>3.3048500000000001</c:v>
                </c:pt>
                <c:pt idx="1">
                  <c:v>9.3219700000000003</c:v>
                </c:pt>
                <c:pt idx="2">
                  <c:v>17.127079999999999</c:v>
                </c:pt>
                <c:pt idx="3">
                  <c:v>32.558500000000002</c:v>
                </c:pt>
                <c:pt idx="4">
                  <c:v>50.657800000000002</c:v>
                </c:pt>
                <c:pt idx="5">
                  <c:v>59.311700000000002</c:v>
                </c:pt>
                <c:pt idx="6">
                  <c:v>224.06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2CF-4EE6-8B07-D322ABA281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8312032"/>
        <c:axId val="1528314112"/>
      </c:scatterChart>
      <c:valAx>
        <c:axId val="1528312032"/>
        <c:scaling>
          <c:orientation val="minMax"/>
          <c:max val="8000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o. of Cells</a:t>
                </a:r>
              </a:p>
            </c:rich>
          </c:tx>
          <c:layout>
            <c:manualLayout>
              <c:xMode val="edge"/>
              <c:yMode val="edge"/>
              <c:x val="0.44334991154264886"/>
              <c:y val="0.918042093070223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\K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4112"/>
        <c:crossesAt val="0"/>
        <c:crossBetween val="midCat"/>
        <c:majorUnit val="100000"/>
        <c:dispUnits>
          <c:builtInUnit val="thousands"/>
        </c:dispUnits>
      </c:valAx>
      <c:valAx>
        <c:axId val="1528314112"/>
        <c:scaling>
          <c:orientation val="minMax"/>
          <c:max val="25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Runtime (second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2032"/>
        <c:crosses val="autoZero"/>
        <c:crossBetween val="midCat"/>
        <c:majorUnit val="500"/>
        <c:minorUnit val="1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563832705539272"/>
          <c:y val="0.10678076490306478"/>
          <c:w val="0.29885603351661322"/>
          <c:h val="0.17745244600787963"/>
        </c:manualLayout>
      </c:layout>
      <c:overlay val="0"/>
      <c:spPr>
        <a:solidFill>
          <a:sysClr val="window" lastClr="FFFFFF"/>
        </a:solidFill>
        <a:ln>
          <a:solidFill>
            <a:sysClr val="windowText" lastClr="000000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oncourse T6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latin typeface="Concourse T6" pitchFamily="2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A83B6-083E-065C-107A-B535518290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20DE35-91D6-B6F3-F644-C77AF95F6E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2F504-7B53-CEB0-CA0D-813C58CEA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AD0F2-1CD1-25C5-C2D8-26ACD3D5E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A84C90-524D-EEAE-9745-E3FB95E60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420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251C3-DDB1-C2EF-29FA-86F28C91F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5D2973-F08F-6A4D-13DB-F383C6E54C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3AE60-C4C3-22DF-CC42-0F574E813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5F72A5-D3E8-3C83-2B72-6EAA35839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70779-8E18-BE6E-78EA-4B8F29091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61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CB3F7D-4250-4A77-A804-107803721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6B10A8-0FCF-11BB-0075-6F512CF865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D3691-6025-1A7D-F90C-46FA86753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FFD83-7CE9-467A-C909-5324F367F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32208-47FB-45B1-184C-3469F6CD8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45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8F054-09FF-FBD7-D889-E23A63682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226CBC-CABD-EB27-12C8-B8706FBDF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79279-1AE0-A894-F7ED-BEA88DC0F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017E4-3D2C-F124-3635-AF65728EE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11494-7852-840A-D70B-42B6F5977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52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D39F1-C6AA-BD71-EC8D-F5D31FB33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C8CA57-24BD-A497-CEC1-162CE96A94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887018-A383-C506-07E0-489F42BE0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20CB9-A8E6-8B60-E317-ACB679753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1C407-5C88-E070-9027-6D4D78573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649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1E2C0E-5BFE-B1A2-7A4D-7A074BAB2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888033-4C6C-F8BA-E36C-2C5E210CD3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CCD27B-F5DD-7732-FC88-57F11B3845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3EA29-1C67-85C0-66DA-2002A55AD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287CEB-2A65-DED6-3D19-8C0957573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FBE716-19C7-74BE-81F0-C9A61FEB1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62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A71D7-ABEB-A545-A283-8DD8271D4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AA7FEB-B295-B313-B3C0-C34CE7A283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8BC3D5-6763-9851-F486-E96AD9B274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05A0BA-3990-BF92-B409-833A8D9EEA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0E68AE-C11A-47D1-541C-0E6A740690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E497DB-60F8-8536-E6BA-C1AF06C6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24AAB7-835B-ADB2-1B04-28D0F55F0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CC5BA0-2EB8-00AB-1259-5A527C17F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745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A4B51-2AC0-A836-4470-937C59560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94C62F-FEFF-10E5-8045-335E40FA9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320175-7F11-2FB7-A9AB-E0B49A64C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064D29-AAC2-4346-0AED-1338677B3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14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FFD398-62FB-EC93-A2A4-A849B7A67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F68241-E78B-2853-EBC3-05A0B59DC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58E42E-1D34-B086-5283-D716F3395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24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4E714-659D-628A-D264-7F2968F81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5477A6-9416-41FC-29AD-F26534E3FC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3C67BB-5CBA-D937-5C5C-B55BA868B6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DAD277-5926-1B90-7658-A6D2BF683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833919-30FF-55AC-0B49-DCC44FBFA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58F0E-E66A-D34B-245E-102272141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448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C5018-5BB5-536E-B0C4-612E01897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186F04-7752-6760-3B39-C0D9B257E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ADCDAB-1479-706C-8E9C-A784BC06E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CCFD1-D925-CC0D-14F7-D9CDF8513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2BEE1-E4BF-9183-6FD0-295A321EB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04A72F-7474-CFB4-FF54-8DDD381C4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4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A9C3F6-E7EE-FC21-A66F-6605CD859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6AF019-3C79-C179-2D15-5DEEDD577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26153-0B2E-7C87-2877-B2190CDE8F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EE42A9-2B1C-1ACB-9543-E1003E8FE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2D0AA-8888-FEF1-2CB1-445AAB3A2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13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EA02FF11-01C6-4F6A-8571-DE9468DB79DE}"/>
              </a:ext>
            </a:extLst>
          </p:cNvPr>
          <p:cNvGraphicFramePr>
            <a:graphicFrameLocks/>
          </p:cNvGraphicFramePr>
          <p:nvPr/>
        </p:nvGraphicFramePr>
        <p:xfrm>
          <a:off x="6096000" y="1881188"/>
          <a:ext cx="3838573" cy="37433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D565DD7-938D-1E2A-1C19-B166FF773CAC}"/>
              </a:ext>
            </a:extLst>
          </p:cNvPr>
          <p:cNvSpPr txBox="1"/>
          <p:nvPr/>
        </p:nvSpPr>
        <p:spPr>
          <a:xfrm>
            <a:off x="1866900" y="533400"/>
            <a:ext cx="9183733" cy="92333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4 - Comparison of integration methods using matrices containing union of genes for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varying number of 10X Genomics PBMC datasets/cells/gene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0135393-02EC-83D7-CE5D-3961F2FC349D}"/>
              </a:ext>
            </a:extLst>
          </p:cNvPr>
          <p:cNvGraphicFramePr>
            <a:graphicFrameLocks/>
          </p:cNvGraphicFramePr>
          <p:nvPr/>
        </p:nvGraphicFramePr>
        <p:xfrm>
          <a:off x="2257427" y="1881188"/>
          <a:ext cx="3838573" cy="37433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02460183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uru, Srinivas</dc:creator>
  <cp:lastModifiedBy>Aluru, Srinivas</cp:lastModifiedBy>
  <cp:revision>10</cp:revision>
  <dcterms:created xsi:type="dcterms:W3CDTF">2024-11-07T18:07:59Z</dcterms:created>
  <dcterms:modified xsi:type="dcterms:W3CDTF">2024-11-07T18:34:48Z</dcterms:modified>
</cp:coreProperties>
</file>